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8" r:id="rId2"/>
  </p:sldIdLst>
  <p:sldSz cx="6858000" cy="9144000" type="screen4x3"/>
  <p:notesSz cx="6985000" cy="9271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20">
          <p15:clr>
            <a:srgbClr val="A4A3A4"/>
          </p15:clr>
        </p15:guide>
        <p15:guide id="2" pos="220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65" autoAdjust="0"/>
    <p:restoredTop sz="96265" autoAdjust="0"/>
  </p:normalViewPr>
  <p:slideViewPr>
    <p:cSldViewPr>
      <p:cViewPr varScale="1">
        <p:scale>
          <a:sx n="84" d="100"/>
          <a:sy n="84" d="100"/>
        </p:scale>
        <p:origin x="3000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>
      <p:cViewPr varScale="1">
        <p:scale>
          <a:sx n="95" d="100"/>
          <a:sy n="95" d="100"/>
        </p:scale>
        <p:origin x="-4014" y="-90"/>
      </p:cViewPr>
      <p:guideLst>
        <p:guide orient="horz" pos="2920"/>
        <p:guide pos="220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827E9681-EF6E-443D-AD20-AB8EAFD34C1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A4DCF7-40DC-469D-BCC6-ED5555FCFE75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956050" y="0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336B58B9-7C8F-4BA3-9758-5BB9041CCE03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D8EF9D18-5B29-45A7-9A27-0A9A10EC512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89163" y="695325"/>
            <a:ext cx="2606675" cy="3476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BDBFBC90-8C34-4DB5-A1A4-41536F23C5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98500" y="4403725"/>
            <a:ext cx="5588000" cy="41719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BA0A6A-A45D-4F5E-AE54-658E8BE01B9D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805863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9DE421-49C6-417F-B16E-2F13AB73C77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956050" y="8805863"/>
            <a:ext cx="3027363" cy="46355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7DA0752-6B18-44EB-BEE1-E9083A4D4F1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1B812A-48E5-49BC-80E9-0675F5EAD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710625-5EC8-4D29-9026-46FCFC9D5661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23A00C-3F6F-4827-95F6-7A651334C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BD01C-BB21-4E4D-AFF5-6C85B7356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F8A27DD-4CD3-4CBA-8DA9-F449D3553A9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79293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88D704-19A7-43E2-9E99-148F5C651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2324E5-E87E-4CC7-98E8-4B79831EC6CF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B62485-2E14-470C-A7E6-889D27261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A1C3C2-C968-4F29-A772-8E2423A93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CD5E43-12AC-4D9F-9B7D-98DEB55E988A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28762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5C9D21-68BD-41B7-9542-B1B873663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48EDE8-96D2-419D-82B1-9B8B8300BFDD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594A7E-FED3-4EB5-9A18-787D0D3FD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F5DC79-39C2-40CD-A829-3C0AF0B16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07CCED1-A290-463D-ABEC-D006A5C0FD7F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75062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ECA2F5-DF6D-4070-8C20-5F2D701DD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BB0E84-EED4-4B5A-BB18-35EFF9D89C46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BCA79F-312D-4499-9642-7BA3E23F4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25C58B-A3DA-4DC3-BE46-AC15A7243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C13AF73-6466-463D-A769-577CAD3FC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54228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41E2DD-02C7-4A4F-9A8F-8620BB40A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3EB0A7-B52E-453E-8176-B0F5F48E5A96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DF48F8-5696-493C-ACAE-C96BD30A0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0DB8C3-3574-46A9-A4FC-3ED222247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C00B60E-36D8-4C10-A2E1-E70DB80F80B8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46995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D4DC778-91A1-4ED8-942B-FC8CF4044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F79885-4051-4760-AE20-DD283F81F802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144CD2A-46E7-4867-B243-D10A51544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76E993B-9DED-41CE-917A-65B4E472E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F7952B-3C50-4A52-BE36-DC43F6C31EB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78203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E0181BC8-27E7-4E91-A1CF-57256C51B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91E7A4-49BD-45BC-9871-02A5BCB44B97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AA1B863F-B867-4E79-91BC-D4769A385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693B4D0F-AAB4-4482-8B2A-3FA2F4E67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8169E2-0EF9-4D0F-808D-455C3A5E203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6048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977994D9-467C-4DA6-BAE6-14592C32A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B081EF-60A6-4EAE-BC12-020E57D07506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F72DCA05-300A-4C95-8C3B-D91FBEADA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1B09A9BF-94AC-41C7-B3BB-B439FC1AD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DC6055F-9BC7-422F-9DB8-8C7134CDA26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58795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42D3D224-BEF0-4A94-B976-FE44677F0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2297D3-59D5-4C54-BE71-5C0A5E073C75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CD1125E-C50B-474F-B13A-69715597F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CDA9005-8207-4CB5-AD0C-EB4C0CA0D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BE195B-15E4-47F9-AAD9-318A3584ACB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28260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6B7EA9-6735-481B-8EF5-DA7AC388A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29B88E-463F-47E9-8572-5B9A1837A842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60148D-7F4E-4061-B60D-60D10643B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4864CA4D-963C-4254-B65D-24225FB2A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90085E-E35B-418C-B2FA-ADF495EF744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38483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D9B7DB92-A68E-43E3-BFFF-DC14EC29F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EDBAA7-70BA-43AE-84E8-ADC2D5DDBD4C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7A82BE2-B420-4BDB-A107-1A5D9A53A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0D309E75-E36D-4373-80A9-8E17D7BBA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722EB4-1912-422D-A991-386C724275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2532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DB69C168-99B4-4F31-AD11-1DBECBAA8C97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AE1843CC-90C5-4A18-9157-07FBF5E28B19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773CD2-63F0-4D65-9AF1-AB6D45695B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C831786-5D89-49F6-951E-93DD53A249FB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493193-3CD5-49E6-A644-26D6BAE3CE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522106-3B9D-46B7-B83F-EA5F99AA06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ADE80974-27FF-4BDF-B638-A70D8A350DA1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3D5FD97B-3481-47A1-80EF-20BA5BD807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646" y="152400"/>
            <a:ext cx="154561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Supplementary Figure 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E0ADD7E-D970-40E4-9064-507AA8550564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677" y="892851"/>
            <a:ext cx="3118407" cy="237333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0C415B1-BC27-4650-90A8-040113A75121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393" y="893278"/>
            <a:ext cx="3164452" cy="23733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73A63A5-15EE-4CC8-A7D1-4179166A83A2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4184" y="3962400"/>
            <a:ext cx="3164451" cy="237333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EA27C75-7A6D-4FD3-B644-2B6DC0C5C04E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918" y="3962400"/>
            <a:ext cx="3164453" cy="237333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4E08D2D-6517-42C5-B1AD-D89275E9007E}"/>
              </a:ext>
            </a:extLst>
          </p:cNvPr>
          <p:cNvSpPr txBox="1"/>
          <p:nvPr/>
        </p:nvSpPr>
        <p:spPr>
          <a:xfrm>
            <a:off x="1821135" y="3962399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59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951ED0D-CB88-48C5-B0EF-BFBBBCAFF1EC}"/>
              </a:ext>
            </a:extLst>
          </p:cNvPr>
          <p:cNvSpPr txBox="1"/>
          <p:nvPr/>
        </p:nvSpPr>
        <p:spPr>
          <a:xfrm>
            <a:off x="1107924" y="90835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59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7CFCE3F-4F9A-41D0-BBB8-27E271F35242}"/>
              </a:ext>
            </a:extLst>
          </p:cNvPr>
          <p:cNvSpPr txBox="1"/>
          <p:nvPr/>
        </p:nvSpPr>
        <p:spPr>
          <a:xfrm>
            <a:off x="1866581" y="90835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0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17274DD-993D-4D56-A6C3-7759877D4048}"/>
              </a:ext>
            </a:extLst>
          </p:cNvPr>
          <p:cNvSpPr txBox="1"/>
          <p:nvPr/>
        </p:nvSpPr>
        <p:spPr>
          <a:xfrm>
            <a:off x="2675892" y="908357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0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CDF88A-237B-4EC9-BFD3-185F56740343}"/>
              </a:ext>
            </a:extLst>
          </p:cNvPr>
          <p:cNvSpPr txBox="1"/>
          <p:nvPr/>
        </p:nvSpPr>
        <p:spPr>
          <a:xfrm>
            <a:off x="5375364" y="913536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1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DE8E09-86EE-4B4A-8079-480476455964}"/>
              </a:ext>
            </a:extLst>
          </p:cNvPr>
          <p:cNvSpPr txBox="1"/>
          <p:nvPr/>
        </p:nvSpPr>
        <p:spPr>
          <a:xfrm>
            <a:off x="4399441" y="908357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1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3DF2E2B-5097-48EE-AA95-9295182AB122}"/>
              </a:ext>
            </a:extLst>
          </p:cNvPr>
          <p:cNvSpPr txBox="1"/>
          <p:nvPr/>
        </p:nvSpPr>
        <p:spPr>
          <a:xfrm>
            <a:off x="3535983" y="904011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0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8910BA5-AD77-4A6F-9297-F64D17D123A7}"/>
              </a:ext>
            </a:extLst>
          </p:cNvPr>
          <p:cNvSpPr txBox="1"/>
          <p:nvPr/>
        </p:nvSpPr>
        <p:spPr>
          <a:xfrm>
            <a:off x="270167" y="90835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59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E3431FA-80FF-4C50-A337-1AD4E895FF3A}"/>
              </a:ext>
            </a:extLst>
          </p:cNvPr>
          <p:cNvSpPr txBox="1"/>
          <p:nvPr/>
        </p:nvSpPr>
        <p:spPr>
          <a:xfrm>
            <a:off x="1130029" y="396240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59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0C2F378-944E-447D-939F-42BB9CD14125}"/>
              </a:ext>
            </a:extLst>
          </p:cNvPr>
          <p:cNvSpPr txBox="1"/>
          <p:nvPr/>
        </p:nvSpPr>
        <p:spPr>
          <a:xfrm>
            <a:off x="352426" y="396240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59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98E05A7-FF33-420C-B89B-767B8E68681B}"/>
              </a:ext>
            </a:extLst>
          </p:cNvPr>
          <p:cNvSpPr txBox="1"/>
          <p:nvPr/>
        </p:nvSpPr>
        <p:spPr>
          <a:xfrm>
            <a:off x="2589560" y="3957516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0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05BBAC1-A4A6-4D2E-AEDF-EA9B676662BA}"/>
              </a:ext>
            </a:extLst>
          </p:cNvPr>
          <p:cNvSpPr txBox="1"/>
          <p:nvPr/>
        </p:nvSpPr>
        <p:spPr>
          <a:xfrm>
            <a:off x="5007487" y="3952631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1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BF82ECC-72BD-451E-A158-76A231660D9D}"/>
              </a:ext>
            </a:extLst>
          </p:cNvPr>
          <p:cNvSpPr txBox="1"/>
          <p:nvPr/>
        </p:nvSpPr>
        <p:spPr>
          <a:xfrm>
            <a:off x="4234612" y="3952632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0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1D829A7-21E3-4ADE-AA6A-122081894B87}"/>
              </a:ext>
            </a:extLst>
          </p:cNvPr>
          <p:cNvSpPr txBox="1"/>
          <p:nvPr/>
        </p:nvSpPr>
        <p:spPr>
          <a:xfrm>
            <a:off x="3516879" y="395751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0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F769B31-411A-4CDF-9E5B-294A56A2B7F3}"/>
              </a:ext>
            </a:extLst>
          </p:cNvPr>
          <p:cNvSpPr txBox="1"/>
          <p:nvPr/>
        </p:nvSpPr>
        <p:spPr>
          <a:xfrm>
            <a:off x="5895890" y="3962399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461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658E397-74B1-446F-B874-113D02D08ECC}"/>
              </a:ext>
            </a:extLst>
          </p:cNvPr>
          <p:cNvSpPr txBox="1"/>
          <p:nvPr/>
        </p:nvSpPr>
        <p:spPr>
          <a:xfrm>
            <a:off x="1490572" y="3606958"/>
            <a:ext cx="37325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u="sng" dirty="0"/>
              <a:t>Western diet mice collagenase-digested livers (N=8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B2DE8DC-BEA0-473B-A303-A8D3BD29E8E3}"/>
              </a:ext>
            </a:extLst>
          </p:cNvPr>
          <p:cNvSpPr txBox="1"/>
          <p:nvPr/>
        </p:nvSpPr>
        <p:spPr>
          <a:xfrm>
            <a:off x="1528466" y="537205"/>
            <a:ext cx="3656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u="sng" dirty="0"/>
              <a:t>Normal diet mice collagenase-digested livers (N=7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6FCA12E-29F3-4E53-9782-308C91582B9F}"/>
              </a:ext>
            </a:extLst>
          </p:cNvPr>
          <p:cNvSpPr txBox="1"/>
          <p:nvPr/>
        </p:nvSpPr>
        <p:spPr>
          <a:xfrm>
            <a:off x="192393" y="4687404"/>
            <a:ext cx="9798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Adipocyte</a:t>
            </a:r>
          </a:p>
          <a:p>
            <a:pPr algn="ctr"/>
            <a:r>
              <a:rPr lang="en-US" sz="1200" b="1" dirty="0"/>
              <a:t>floaters</a:t>
            </a:r>
          </a:p>
        </p:txBody>
      </p:sp>
    </p:spTree>
    <p:extLst>
      <p:ext uri="{BB962C8B-B14F-4D97-AF65-F5344CB8AC3E}">
        <p14:creationId xmlns:p14="http://schemas.microsoft.com/office/powerpoint/2010/main" val="4053461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938</TotalTime>
  <Words>36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cob Couturier</dc:creator>
  <cp:lastModifiedBy>lewis-lab</cp:lastModifiedBy>
  <cp:revision>2507</cp:revision>
  <cp:lastPrinted>2016-08-03T16:35:28Z</cp:lastPrinted>
  <dcterms:created xsi:type="dcterms:W3CDTF">2013-10-25T02:31:22Z</dcterms:created>
  <dcterms:modified xsi:type="dcterms:W3CDTF">2019-04-08T15:16:24Z</dcterms:modified>
</cp:coreProperties>
</file>